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58" autoAdjust="0"/>
    <p:restoredTop sz="94660"/>
  </p:normalViewPr>
  <p:slideViewPr>
    <p:cSldViewPr snapToGrid="0">
      <p:cViewPr varScale="1">
        <p:scale>
          <a:sx n="70" d="100"/>
          <a:sy n="70" d="100"/>
        </p:scale>
        <p:origin x="54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618788-CE7D-99D8-7543-F5B2A2B19C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24D96C8-A676-9CF7-F610-1DA7B6AB39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450AC9-7961-6234-91AA-5AE2E8821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5AF938-17E0-936F-D455-38104F3C1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670A17-3CE5-EF41-5C4D-4C62FE8D9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627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71B1E-FC45-AD69-40A4-48A97FD9AF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90ED0B-8724-895A-2C5A-519B20540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4F0E86-696F-D9AF-A954-F40FD675F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8FB64F-3F0A-4B45-C89E-AD828329C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A2C18-CC4F-0F54-4A25-308826C6F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4328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273B89-15F5-D064-0821-702F1DC9BB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1E1FE1-BA0C-622A-4C09-A3A33BC416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B06E1F-DF3B-3492-C58D-9855B65D8D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82235A-4BBC-5BDD-4F9B-4BDAE820E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4DB67B-6068-C5A7-6D2C-5A787D415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9292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EDB981-1D88-7305-8C36-A48A5E3E3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5DB728-6509-C5F5-EB32-86D22F0D4F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5BA5B8-FC67-44BA-D159-3AB4C8CCD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F2C198-4C1A-0706-3E5D-5C5C78502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DEB829-19D1-F542-C0C8-24B63F5DE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5388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7EED90-6106-3A45-30CE-937B502C32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60A829-B41D-77DF-9C54-ACF1E2A37A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FD9601-839C-D8A9-51FC-F751E2146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1C3C7E-3DD4-03FB-AC57-577DD3689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CA439B-EFD6-1099-E436-FE9594A52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97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E1135-B091-BA2B-AAFC-35F9A4DCFC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9CE90F-ADF1-14BB-F76F-CCA53EB7FF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6E4853-E537-3459-5E7F-431FC53A4C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E35C00-775B-665C-FC83-2EC2A3BD6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862A62-9BBC-31FF-A2BE-2C9F10AF3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E7F920-E078-572B-5B34-7F633313E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2555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E08408-B0BF-22DF-C6DD-8E155F09E0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F47C1A-FA92-DC5B-79C5-DA82267E40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3BD8C1-7A1D-16F9-45C1-4849722E1A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78611B7-652C-B2CC-F51B-3A749A4C68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DB44DB-18D8-420F-D5B3-9BD25B3ED9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6D6947-3524-C7D3-F4B9-E619C9765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BB3374-BF0C-5380-8DBD-78A24F4CA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9C1436-A23F-5597-3860-ADAD4D850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1925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7514E-2A31-C701-BF50-AF8DF822D3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AB6491-3CCC-2A18-7F12-1E8543CD2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C88E1C-689F-38AF-61D2-8350AA2C7E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E83EB3-17A6-4161-7B72-0C1F80F2A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0802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371EAB5-6FFA-39F2-F2CA-0E813FE16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B80AC3F-E1F5-F877-2EDA-006A53BB5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147DCE-6314-2265-9023-6E96FD555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0177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59ABF6-A2C8-E280-7627-AEC5056B9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06D7D5-8685-84BC-7B1C-5287D62006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F34DE7-3BCC-8AB2-4F10-46694B6D49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5A503C-D403-9FFB-CBDF-FDF8A4128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0476C1-3DB7-5D29-4A91-455DA6620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7169BA-17E0-C355-FEA0-6AEFF866C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581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A96243-9935-1964-16A6-2C4A39F5E0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4D3C8C-7165-A604-D80C-D7CF9F8358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EBF026-E635-D5CF-AA22-24407FC14A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1D200-D40F-BA4E-CB04-B1E5A4122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03227B-CC10-2B2E-8A03-8116E8844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FCF7E9-2E90-BC50-8ADB-C5333C4C6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0400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5341E2-9FB0-3340-51D5-024370228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5E6688-E407-18CF-1C1E-89C5CD23DA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416146-2910-82B6-929B-F9261E13ED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EDBCD-C426-4B8C-BBC3-FD6C2E70F172}" type="datetimeFigureOut">
              <a:rPr lang="en-GB" smtClean="0"/>
              <a:t>10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36E688-CEDB-C421-B449-D752258BE4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52483B-29A9-9756-1D84-5A7457057F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35137-00F7-414A-80A5-95E3871D82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5211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078145FA-8DB9-D538-1461-9CAA546C78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99078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E1EA82E-0D21-88B6-4649-6FDB48CD64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56" y="0"/>
            <a:ext cx="11613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69776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79594E4-84E4-6223-B764-F7F6F5E8BE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1412" y="277158"/>
            <a:ext cx="9409176" cy="6303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48444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70E5473-14FE-7D5C-477D-DBFCB4E9A6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56" y="0"/>
            <a:ext cx="11613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794153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D21FDED-1E17-5F1F-ABE0-D850B27F62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56" y="0"/>
            <a:ext cx="11613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957257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57E3CD4-5F5B-89AC-3F50-BD34E48B22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56" y="0"/>
            <a:ext cx="11613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045693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4F54E2B-0547-0F33-055E-86BD1EB466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56" y="0"/>
            <a:ext cx="11613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47398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1E5C18F-63E0-1906-8BAF-B2EF1CBD42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56" y="0"/>
            <a:ext cx="11613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200619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CF6BD245-CF35-E8B3-37AD-32043A7230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319553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2BF9879-B23B-B810-4156-DDEBB78902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" y="992124"/>
            <a:ext cx="12188952" cy="4873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669162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4556976-D6AE-C1EA-24E2-CEB705D698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56" y="0"/>
            <a:ext cx="11613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8780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67A29F1-8576-7022-6696-6A5001A259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399" y="268748"/>
            <a:ext cx="9773099" cy="59606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60316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CA5F905-EA4C-1BBD-82AD-9EB265226E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150" y="734324"/>
            <a:ext cx="10978093" cy="53893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80426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1AD9CDD-11B5-1957-F7E0-12AA582787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95" y="1047750"/>
            <a:ext cx="11072009" cy="5086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04689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61CF5F1-C684-5748-B56A-19C422CE11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950" y="400671"/>
            <a:ext cx="10639850" cy="60191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24070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AEA079C-EB5A-1888-40E5-C39CE6A172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599" y="143431"/>
            <a:ext cx="11740504" cy="6371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32941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6C5422D-E8F3-0393-92B8-C69BCEF6E2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500"/>
          <a:stretch/>
        </p:blipFill>
        <p:spPr>
          <a:xfrm>
            <a:off x="0" y="-110262"/>
            <a:ext cx="12192000" cy="66594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39046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4D56328-253E-E4FC-DCEC-04EC6066D1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658" y="180226"/>
            <a:ext cx="10806684" cy="64975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45529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E92D379-8E75-2A2E-3646-1F60EEDC30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56" y="0"/>
            <a:ext cx="11613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7793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99</TotalTime>
  <Words>0</Words>
  <Application>Microsoft Office PowerPoint</Application>
  <PresentationFormat>Widescreen</PresentationFormat>
  <Paragraphs>0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LYASS Y.</dc:creator>
  <cp:lastModifiedBy>ILLYASS Y.</cp:lastModifiedBy>
  <cp:revision>11</cp:revision>
  <dcterms:created xsi:type="dcterms:W3CDTF">2022-11-04T23:15:05Z</dcterms:created>
  <dcterms:modified xsi:type="dcterms:W3CDTF">2022-11-13T04:17:59Z</dcterms:modified>
</cp:coreProperties>
</file>